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248C3E4-9239-D604-9635-C5EA8AF55C0D}" name="James Burns" initials="JB" userId="S::je.burns@mail.utoronto.ca::e28dd781-7100-42e5-b0c1-7d4c6953c02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53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5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89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74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31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55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511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64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95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94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17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824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86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BB9BB097-A979-656E-42D8-A7944EF16B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5350" y="276916"/>
            <a:ext cx="4050000" cy="32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D405338-A80F-5ACD-6B6F-571E04DCC6F4}"/>
              </a:ext>
            </a:extLst>
          </p:cNvPr>
          <p:cNvSpPr txBox="1"/>
          <p:nvPr/>
        </p:nvSpPr>
        <p:spPr>
          <a:xfrm>
            <a:off x="287958" y="119080"/>
            <a:ext cx="4141167" cy="3508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DC 9: Figure 6S(a-c): Bone turnover marker - C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oss-linked C telopeptides of Type I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ntermediate values vs. baseline*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ngitudinal changes TAF vs. TDF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Percentage changes TAF vs. TDF</a:t>
            </a:r>
          </a:p>
          <a:p>
            <a:pPr marL="342900" indent="-342900" algn="just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TAF: red, TDF: blue</a:t>
            </a:r>
          </a:p>
          <a:p>
            <a:pPr algn="just"/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relates to the date of the first measurement of the parameter in ques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TX: C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oss-linked C telopeptides of Type 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, TAF: tenofovir alafenamide fumarate, TDF: tenofovir disoproxil fumarate.</a:t>
            </a:r>
          </a:p>
          <a:p>
            <a:pPr marL="342900" indent="-342900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4FB4C1-6886-C5B6-2F56-7D3DD24878D0}"/>
              </a:ext>
            </a:extLst>
          </p:cNvPr>
          <p:cNvSpPr txBox="1"/>
          <p:nvPr/>
        </p:nvSpPr>
        <p:spPr>
          <a:xfrm>
            <a:off x="4371975" y="1143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753C4D-4ECA-84CF-1704-64134EED93C3}"/>
              </a:ext>
            </a:extLst>
          </p:cNvPr>
          <p:cNvSpPr txBox="1"/>
          <p:nvPr/>
        </p:nvSpPr>
        <p:spPr>
          <a:xfrm>
            <a:off x="295275" y="3228975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63E658-B0AE-5C26-ACC0-06644E1390BE}"/>
              </a:ext>
            </a:extLst>
          </p:cNvPr>
          <p:cNvSpPr txBox="1"/>
          <p:nvPr/>
        </p:nvSpPr>
        <p:spPr>
          <a:xfrm>
            <a:off x="4419600" y="3200400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10" name="Picture 9" descr="Chart, line chart&#10;&#10;Description automatically generated">
            <a:extLst>
              <a:ext uri="{FF2B5EF4-FFF2-40B4-BE49-F238E27FC236}">
                <a16:creationId xmlns:a16="http://schemas.microsoft.com/office/drawing/2014/main" id="{780C2864-379E-40CF-21B2-EAA88BB278A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672" y="3771900"/>
            <a:ext cx="3771900" cy="2743200"/>
          </a:xfrm>
          <a:prstGeom prst="rect">
            <a:avLst/>
          </a:prstGeom>
        </p:spPr>
      </p:pic>
      <p:pic>
        <p:nvPicPr>
          <p:cNvPr id="12" name="Picture 11" descr="Chart&#10;&#10;Description automatically generated">
            <a:extLst>
              <a:ext uri="{FF2B5EF4-FFF2-40B4-BE49-F238E27FC236}">
                <a16:creationId xmlns:a16="http://schemas.microsoft.com/office/drawing/2014/main" id="{EA42BF12-26F1-6EC0-4345-F7942B57792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3570" y="3771900"/>
            <a:ext cx="37719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3871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</TotalTime>
  <Words>87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ort diagram?</dc:title>
  <dc:creator>David Dunn</dc:creator>
  <cp:lastModifiedBy>Arun Sharma</cp:lastModifiedBy>
  <cp:revision>26</cp:revision>
  <dcterms:created xsi:type="dcterms:W3CDTF">2022-04-11T09:37:24Z</dcterms:created>
  <dcterms:modified xsi:type="dcterms:W3CDTF">2024-02-29T09:22:33Z</dcterms:modified>
</cp:coreProperties>
</file>